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4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146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65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750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444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216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440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313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875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34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464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52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608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26" t="4768" r="20674" b="7026"/>
          <a:stretch/>
        </p:blipFill>
        <p:spPr>
          <a:xfrm>
            <a:off x="2742118" y="1520433"/>
            <a:ext cx="3253625" cy="4313461"/>
          </a:xfrm>
        </p:spPr>
      </p:pic>
      <p:sp>
        <p:nvSpPr>
          <p:cNvPr id="5" name="文本框 48"/>
          <p:cNvSpPr txBox="1"/>
          <p:nvPr/>
        </p:nvSpPr>
        <p:spPr>
          <a:xfrm>
            <a:off x="3595882" y="5893689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793696" y="5746882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26"/>
          <p:cNvSpPr txBox="1"/>
          <p:nvPr/>
        </p:nvSpPr>
        <p:spPr>
          <a:xfrm>
            <a:off x="3284014" y="5738555"/>
            <a:ext cx="2812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26"/>
          <p:cNvSpPr txBox="1"/>
          <p:nvPr/>
        </p:nvSpPr>
        <p:spPr>
          <a:xfrm>
            <a:off x="3773954" y="5745804"/>
            <a:ext cx="29237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26"/>
          <p:cNvSpPr txBox="1"/>
          <p:nvPr/>
        </p:nvSpPr>
        <p:spPr>
          <a:xfrm>
            <a:off x="4267591" y="5738555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26"/>
          <p:cNvSpPr txBox="1"/>
          <p:nvPr/>
        </p:nvSpPr>
        <p:spPr>
          <a:xfrm>
            <a:off x="4751683" y="5745804"/>
            <a:ext cx="2420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909868" y="3343988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895027" y="3533718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48"/>
          <p:cNvSpPr txBox="1"/>
          <p:nvPr/>
        </p:nvSpPr>
        <p:spPr>
          <a:xfrm>
            <a:off x="5909851" y="3715749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26"/>
          <p:cNvSpPr txBox="1"/>
          <p:nvPr/>
        </p:nvSpPr>
        <p:spPr>
          <a:xfrm>
            <a:off x="5236429" y="5753125"/>
            <a:ext cx="2420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48"/>
          <p:cNvSpPr txBox="1"/>
          <p:nvPr/>
        </p:nvSpPr>
        <p:spPr>
          <a:xfrm>
            <a:off x="3063357" y="1296335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85617" y="1554177"/>
            <a:ext cx="21044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ition metal ion homeosta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763518" y="1766793"/>
            <a:ext cx="112696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28341" y="1973008"/>
            <a:ext cx="235170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-affinity iron ion transmembrane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354112" y="2380022"/>
            <a:ext cx="55091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430119" y="2804305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osmotic str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59918" y="2189641"/>
            <a:ext cx="225237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anscription, DNA-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mplated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200600" y="2595031"/>
            <a:ext cx="210443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per ion homeosta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709292" y="3009358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pe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trans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016616" y="3223324"/>
            <a:ext cx="209683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reactive oxygen specie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84837" y="3848280"/>
            <a:ext cx="246199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ified amino acid 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732765" y="3429797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ll biogenesi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222884" y="3645063"/>
            <a:ext cx="166444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leaf developmen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561337" y="4063545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368012" y="4268239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i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l ion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532032" y="4468858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bonuclea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320606" y="4680786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esium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elata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462706" y="4881639"/>
            <a:ext cx="153132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per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peron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184296" y="5088955"/>
            <a:ext cx="174684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-specif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85618" y="5287018"/>
            <a:ext cx="208251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cium-dependent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lipid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257620" y="5521443"/>
            <a:ext cx="174684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esium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elata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lex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247334" y="1569304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762481" y="1777921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571803" y="1980155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4249336" y="2196841"/>
            <a:ext cx="35402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205070" y="2404892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4106485" y="2826765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4036590" y="3032280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4106484" y="2610097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786974" y="3239212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791906" y="3444265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707901" y="3649318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706514" y="3866004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692693" y="4073843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5160380" y="4287957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3979434" y="4493985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976957" y="4691626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981887" y="4904090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814156" y="5118434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789438" y="5323487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3987079" y="5543363"/>
            <a:ext cx="257115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42402" y="363852"/>
            <a:ext cx="683200" cy="2959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</a:t>
            </a:r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5</a:t>
            </a:r>
            <a:endParaRPr lang="en-US" altLang="zh-CN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3876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16</Words>
  <Application>Microsoft Office PowerPoint</Application>
  <PresentationFormat>自定义</PresentationFormat>
  <Paragraphs>5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1:06Z</dcterms:modified>
</cp:coreProperties>
</file>